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15"/>
  </p:notesMasterIdLst>
  <p:sldIdLst>
    <p:sldId id="256" r:id="rId2"/>
    <p:sldId id="261" r:id="rId3"/>
    <p:sldId id="258" r:id="rId4"/>
    <p:sldId id="271" r:id="rId5"/>
    <p:sldId id="264" r:id="rId6"/>
    <p:sldId id="266" r:id="rId7"/>
    <p:sldId id="259" r:id="rId8"/>
    <p:sldId id="262" r:id="rId9"/>
    <p:sldId id="268" r:id="rId10"/>
    <p:sldId id="269" r:id="rId11"/>
    <p:sldId id="270" r:id="rId12"/>
    <p:sldId id="263" r:id="rId13"/>
    <p:sldId id="265" r:id="rId14"/>
  </p:sldIdLst>
  <p:sldSz cx="6858000" cy="9144000" type="screen4x3"/>
  <p:notesSz cx="6858000" cy="9144000"/>
  <p:defaultTextStyle>
    <a:defPPr>
      <a:defRPr lang="he-IL"/>
    </a:defPPr>
    <a:lvl1pPr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r" defTabSz="914400" rtl="1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r" defTabSz="914400" rtl="1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r" defTabSz="914400" rtl="1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r" defTabSz="914400" rtl="1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סגנון ביניים 2 - הדגשה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aximized" horzBarState="maximized">
    <p:restoredLeft sz="84632" autoAdjust="0"/>
    <p:restoredTop sz="93107" autoAdjust="0"/>
  </p:normalViewPr>
  <p:slideViewPr>
    <p:cSldViewPr>
      <p:cViewPr>
        <p:scale>
          <a:sx n="75" d="100"/>
          <a:sy n="75" d="100"/>
        </p:scale>
        <p:origin x="-1302" y="105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840E5F9A-239E-4DF6-98DA-E49CCBF05ED7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pPr lvl="0"/>
            <a:endParaRPr lang="he-IL" noProof="0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 noProof="0" smtClean="0"/>
              <a:t>לחץ כדי לערוך סגנונות טקסט של תבנית בסיס</a:t>
            </a:r>
          </a:p>
          <a:p>
            <a:pPr lvl="1"/>
            <a:r>
              <a:rPr lang="he-IL" noProof="0" smtClean="0"/>
              <a:t>רמה שנייה</a:t>
            </a:r>
          </a:p>
          <a:p>
            <a:pPr lvl="2"/>
            <a:r>
              <a:rPr lang="he-IL" noProof="0" smtClean="0"/>
              <a:t>רמה שלישית</a:t>
            </a:r>
          </a:p>
          <a:p>
            <a:pPr lvl="3"/>
            <a:r>
              <a:rPr lang="he-IL" noProof="0" smtClean="0"/>
              <a:t>רמה רביעית</a:t>
            </a:r>
          </a:p>
          <a:p>
            <a:pPr lvl="4"/>
            <a:r>
              <a:rPr lang="he-IL" noProof="0" smtClean="0"/>
              <a:t>רמה חמישית</a:t>
            </a:r>
            <a:endParaRPr lang="he-IL" noProof="0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B6BCC9AE-F86A-4896-969A-474CE8A42526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r" rtl="1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rtl="1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rtl="1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rtl="1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rtl="1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410" name="מציין מיקום של הערות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he-IL" smtClean="0"/>
          </a:p>
        </p:txBody>
      </p:sp>
      <p:sp>
        <p:nvSpPr>
          <p:cNvPr id="16387" name="מציין מיקום של מספר שקופית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A82CB083-71CC-41B7-8E88-DD207C7F8C9B}" type="slidenum">
              <a:rPr lang="he-IL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3</a:t>
            </a:fld>
            <a:endParaRPr lang="he-IL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C2FA4E-FF0E-47FB-9366-71C0D9267B18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8A6CB0-3C96-431A-98B8-CBAF445A4F18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201C34-4DD3-49D3-8780-802673AEB42A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1C9F99-C53C-4600-B7F6-B3324C88C3AB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62702B-3F56-48FD-9C10-67A758D3D3F5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38FCCB-E13E-4DFC-8485-215BA1E2BCD6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B7EFD7-6A3B-4F5D-B258-841DBBC4DA9E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C8BB66-52BD-4F5C-835D-4E2939B8D2E3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DE2FF6-F874-4E5A-B924-B1EAB6F106D4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C3187E-393F-473A-A572-515E92EA0ABE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48E576-8017-4C54-9753-95E2CC2A2166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6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7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0DD539-6644-48A3-B4D9-B3D8F99C55AF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7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3C682F-D8F4-48E7-9450-D5143C0604D8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8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9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82EDEB-D1B7-46CD-AFF6-224E75EFE319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5254AB-B72E-4BF1-85FE-F4F7A95E2FC4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4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5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1A2436-ADA4-494B-BEF0-57021B0B1B3A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B26289-82B4-4188-A9C4-57A3DA9FF01E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3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4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37ED1A-4D0B-45BE-8ED9-8509E48129BC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664452-5987-400A-AAD8-6E69A8C8A86F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6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7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F6C1E0-A326-4EF1-94FF-0318CFC4ADC0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1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he-IL" noProof="0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642C0E-B18D-4980-896E-630DBEA55823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6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7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C6E4EC-5F3B-4074-90EE-1B89858CAC1F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מציין מיקום של כותרת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he-IL" smtClean="0"/>
              <a:t>לחץ כדי לערוך סגנון כותרת של תבנית בסיס</a:t>
            </a:r>
          </a:p>
        </p:txBody>
      </p:sp>
      <p:sp>
        <p:nvSpPr>
          <p:cNvPr id="1027" name="מציין מיקום טקסט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83E4F24-0E64-4FF1-84FD-950E43C6871E}" type="datetimeFigureOut">
              <a:rPr lang="he-IL"/>
              <a:pPr>
                <a:defRPr/>
              </a:pPr>
              <a:t>כ"ה/תשרי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B87CDA6-75CA-4839-A8B3-9174E55C1E38}" type="slidenum">
              <a:rPr lang="he-IL"/>
              <a:pPr>
                <a:defRPr/>
              </a:pPr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1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1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Times New Roman" pitchFamily="18" charset="0"/>
        </a:defRPr>
      </a:lvl2pPr>
      <a:lvl3pPr algn="ctr" rtl="1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Times New Roman" pitchFamily="18" charset="0"/>
        </a:defRPr>
      </a:lvl3pPr>
      <a:lvl4pPr algn="ctr" rtl="1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Times New Roman" pitchFamily="18" charset="0"/>
        </a:defRPr>
      </a:lvl4pPr>
      <a:lvl5pPr algn="ctr" rtl="1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Times New Roman" pitchFamily="18" charset="0"/>
        </a:defRPr>
      </a:lvl5pPr>
      <a:lvl6pPr marL="457200" algn="ctr" rtl="1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Times New Roman" pitchFamily="18" charset="0"/>
        </a:defRPr>
      </a:lvl6pPr>
      <a:lvl7pPr marL="914400" algn="ctr" rtl="1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Times New Roman" pitchFamily="18" charset="0"/>
        </a:defRPr>
      </a:lvl7pPr>
      <a:lvl8pPr marL="1371600" algn="ctr" rtl="1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Times New Roman" pitchFamily="18" charset="0"/>
        </a:defRPr>
      </a:lvl8pPr>
      <a:lvl9pPr marL="1828800" algn="ctr" rtl="1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Times New Roman" pitchFamily="18" charset="0"/>
        </a:defRPr>
      </a:lvl9pPr>
    </p:titleStyle>
    <p:bodyStyle>
      <a:lvl1pPr marL="342900" indent="-342900" algn="r" rtl="1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rtl="1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rtl="1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rtl="1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rtl="1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7.emf"/><Relationship Id="rId4" Type="http://schemas.openxmlformats.org/officeDocument/2006/relationships/image" Target="../media/image36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1.emf"/><Relationship Id="rId4" Type="http://schemas.openxmlformats.org/officeDocument/2006/relationships/image" Target="../media/image40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5.emf"/><Relationship Id="rId4" Type="http://schemas.openxmlformats.org/officeDocument/2006/relationships/image" Target="../media/image44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9.emf"/><Relationship Id="rId4" Type="http://schemas.openxmlformats.org/officeDocument/2006/relationships/image" Target="../media/image4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emf"/><Relationship Id="rId4" Type="http://schemas.openxmlformats.org/officeDocument/2006/relationships/image" Target="../media/image28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3.emf"/><Relationship Id="rId4" Type="http://schemas.openxmlformats.org/officeDocument/2006/relationships/image" Target="../media/image3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7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3375" y="2433638"/>
            <a:ext cx="5903913" cy="3113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38" name="Rectangle 3"/>
          <p:cNvSpPr>
            <a:spLocks noChangeArrowheads="1"/>
          </p:cNvSpPr>
          <p:nvPr/>
        </p:nvSpPr>
        <p:spPr bwMode="auto">
          <a:xfrm>
            <a:off x="186363" y="1258888"/>
            <a:ext cx="201850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rtl="0"/>
            <a:r>
              <a:rPr lang="en-US" b="1" dirty="0"/>
              <a:t>Online </a:t>
            </a:r>
            <a:r>
              <a:rPr lang="en-US" b="1" dirty="0" smtClean="0"/>
              <a:t>Figure S1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7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875" y="827088"/>
            <a:ext cx="3224213" cy="3384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4578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11563" y="4864100"/>
            <a:ext cx="3225800" cy="3384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4579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611563" y="827088"/>
            <a:ext cx="3225800" cy="3384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4580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5875" y="4864100"/>
            <a:ext cx="3224213" cy="3384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25400" y="674688"/>
            <a:ext cx="3240088" cy="236537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0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31750" y="4662488"/>
            <a:ext cx="3208338" cy="29051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0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3627438" y="646113"/>
            <a:ext cx="3209925" cy="26511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0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3622675" y="4529138"/>
            <a:ext cx="3235325" cy="41116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0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24585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11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10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sz="1600" dirty="0">
                <a:latin typeface="Calibri" pitchFamily="34" charset="0"/>
              </a:rPr>
              <a:t>Calcium Carbonate</a:t>
            </a:r>
            <a:endParaRPr lang="he-IL" sz="1600" dirty="0">
              <a:latin typeface="Calibri" pitchFamily="34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1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463925" y="900113"/>
            <a:ext cx="3160713" cy="3419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6688" y="4897438"/>
            <a:ext cx="3146425" cy="3419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03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79388" y="900113"/>
            <a:ext cx="3133725" cy="3419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04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497535" y="4932040"/>
            <a:ext cx="3133725" cy="33681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185738" y="766763"/>
            <a:ext cx="3233737" cy="23495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1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223838" y="4570413"/>
            <a:ext cx="3060700" cy="433387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1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3489325" y="755650"/>
            <a:ext cx="3095625" cy="2540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1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3503613" y="4549775"/>
            <a:ext cx="3155950" cy="4540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1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25609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11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11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sz="1600" dirty="0" err="1">
                <a:latin typeface="Calibri" pitchFamily="34" charset="0"/>
              </a:rPr>
              <a:t>Alfacalcidol</a:t>
            </a:r>
            <a:endParaRPr lang="he-IL" sz="1600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5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038" y="4329113"/>
            <a:ext cx="3278187" cy="290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6626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038" y="946150"/>
            <a:ext cx="3278187" cy="2905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6627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463925" y="946150"/>
            <a:ext cx="3278188" cy="2905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6628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463925" y="4329113"/>
            <a:ext cx="3278188" cy="290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66675" y="877888"/>
            <a:ext cx="3265488" cy="25876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2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69850" y="4092575"/>
            <a:ext cx="3287713" cy="407988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2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3479800" y="865188"/>
            <a:ext cx="3206750" cy="26511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2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3463925" y="4110038"/>
            <a:ext cx="3278188" cy="3905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2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26633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11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12</a:t>
            </a:r>
            <a:endParaRPr lang="en-US" sz="1600" dirty="0">
              <a:latin typeface="Calibri" pitchFamily="34" charset="0"/>
            </a:endParaRPr>
          </a:p>
          <a:p>
            <a:pPr algn="l" rtl="0"/>
            <a:r>
              <a:rPr lang="en-US" sz="1600" dirty="0">
                <a:latin typeface="Calibri" pitchFamily="34" charset="0"/>
              </a:rPr>
              <a:t>Aspirin</a:t>
            </a:r>
            <a:endParaRPr lang="he-IL" sz="1600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49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9538" y="4932363"/>
            <a:ext cx="5257800" cy="1976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0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9538" y="663575"/>
            <a:ext cx="5257800" cy="1976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1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9538" y="2811463"/>
            <a:ext cx="5257800" cy="1976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2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09538" y="7019925"/>
            <a:ext cx="5257800" cy="1976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119063" y="592138"/>
            <a:ext cx="5259387" cy="23495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3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134938" y="4829175"/>
            <a:ext cx="6535737" cy="2635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3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117475" y="2717800"/>
            <a:ext cx="6530975" cy="25717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13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127000" y="6965950"/>
            <a:ext cx="5221288" cy="258763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1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100" dirty="0" smtClean="0">
                <a:solidFill>
                  <a:srgbClr val="000000"/>
                </a:solidFill>
                <a:cs typeface="Arial" charset="0"/>
              </a:rPr>
              <a:t>S13 </a:t>
            </a:r>
            <a:r>
              <a:rPr lang="en-US" sz="11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0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0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27657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11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13</a:t>
            </a:r>
            <a:r>
              <a:rPr lang="en-US" dirty="0" smtClean="0">
                <a:latin typeface="Calibri" pitchFamily="34" charset="0"/>
              </a:rPr>
              <a:t> </a:t>
            </a:r>
            <a:endParaRPr lang="en-US" sz="1600" dirty="0">
              <a:latin typeface="Calibri" pitchFamily="34" charset="0"/>
            </a:endParaRPr>
          </a:p>
          <a:p>
            <a:pPr algn="l" rtl="0"/>
            <a:r>
              <a:rPr lang="en-US" sz="1600" dirty="0">
                <a:latin typeface="Calibri" pitchFamily="34" charset="0"/>
              </a:rPr>
              <a:t>Calcium Channel Blockers</a:t>
            </a:r>
            <a:endParaRPr lang="he-IL" sz="1600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1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9863" y="2843213"/>
            <a:ext cx="6499225" cy="1957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9863" y="755650"/>
            <a:ext cx="6499225" cy="1957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69863" y="4932363"/>
            <a:ext cx="6499225" cy="1957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4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69863" y="7151688"/>
            <a:ext cx="6499225" cy="1957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182563" y="611188"/>
            <a:ext cx="6675437" cy="3397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2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182563" y="4826000"/>
            <a:ext cx="6486525" cy="246063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2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174625" y="2733675"/>
            <a:ext cx="6494463" cy="2540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2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182563" y="6927850"/>
            <a:ext cx="6486525" cy="3810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2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 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5369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41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S2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dirty="0">
                <a:latin typeface="Calibri" pitchFamily="34" charset="0"/>
              </a:rPr>
              <a:t>Beta Blockers</a:t>
            </a:r>
            <a:endParaRPr lang="he-IL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5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9225" y="4972050"/>
            <a:ext cx="6542088" cy="1855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386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49225" y="771525"/>
            <a:ext cx="6542088" cy="1855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387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49225" y="2859088"/>
            <a:ext cx="6542088" cy="1857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388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49225" y="7108825"/>
            <a:ext cx="6542088" cy="1855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תיבת טקסט 20"/>
          <p:cNvSpPr txBox="1"/>
          <p:nvPr/>
        </p:nvSpPr>
        <p:spPr>
          <a:xfrm>
            <a:off x="147638" y="735013"/>
            <a:ext cx="6551612" cy="236537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3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8"/>
          <p:cNvSpPr txBox="1"/>
          <p:nvPr/>
        </p:nvSpPr>
        <p:spPr>
          <a:xfrm>
            <a:off x="157163" y="4859338"/>
            <a:ext cx="6534150" cy="29051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3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17"/>
          <p:cNvSpPr txBox="1"/>
          <p:nvPr/>
        </p:nvSpPr>
        <p:spPr>
          <a:xfrm>
            <a:off x="160338" y="2778125"/>
            <a:ext cx="6530975" cy="280988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3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0" name="תיבת טקסט 3"/>
          <p:cNvSpPr txBox="1"/>
          <p:nvPr/>
        </p:nvSpPr>
        <p:spPr>
          <a:xfrm>
            <a:off x="157163" y="7048500"/>
            <a:ext cx="6534150" cy="26035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3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6393" name="מלבן 1"/>
          <p:cNvSpPr>
            <a:spLocks noChangeArrowheads="1"/>
          </p:cNvSpPr>
          <p:nvPr/>
        </p:nvSpPr>
        <p:spPr bwMode="auto">
          <a:xfrm>
            <a:off x="-26988" y="-36513"/>
            <a:ext cx="6900863" cy="641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S3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dirty="0" err="1">
                <a:latin typeface="Calibri" pitchFamily="34" charset="0"/>
              </a:rPr>
              <a:t>Statins</a:t>
            </a:r>
            <a:endParaRPr lang="he-IL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3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4638" y="684213"/>
            <a:ext cx="6192837" cy="1871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4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74638" y="4572000"/>
            <a:ext cx="6192837" cy="1789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5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74638" y="2555875"/>
            <a:ext cx="6192837" cy="1830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6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74638" y="6497638"/>
            <a:ext cx="6192837" cy="174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274638" y="684213"/>
            <a:ext cx="6192837" cy="38417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4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274638" y="4564063"/>
            <a:ext cx="6297612" cy="34131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4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274638" y="2619375"/>
            <a:ext cx="6192837" cy="3556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4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276225" y="6443663"/>
            <a:ext cx="6127750" cy="433387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4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8441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11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S4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sz="1600" dirty="0">
                <a:latin typeface="Calibri" pitchFamily="34" charset="0"/>
              </a:rPr>
              <a:t>Anti-</a:t>
            </a:r>
            <a:r>
              <a:rPr lang="en-US" sz="1600" dirty="0" err="1">
                <a:latin typeface="Calibri" pitchFamily="34" charset="0"/>
              </a:rPr>
              <a:t>arrhythmics</a:t>
            </a:r>
            <a:endParaRPr lang="he-IL" sz="1600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5888" y="4932363"/>
            <a:ext cx="5834062" cy="1876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5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5888" y="611188"/>
            <a:ext cx="5834062" cy="1874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5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5888" y="2771775"/>
            <a:ext cx="5834062" cy="180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15888" y="7092950"/>
            <a:ext cx="5834062" cy="18748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122238" y="612775"/>
            <a:ext cx="6551612" cy="287338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5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131763" y="4919663"/>
            <a:ext cx="6534150" cy="2889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5 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122238" y="2725738"/>
            <a:ext cx="6530975" cy="406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5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144463" y="7019925"/>
            <a:ext cx="6534150" cy="3651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cs typeface="Arial" charset="0"/>
              </a:rPr>
              <a:t>S5 </a:t>
            </a:r>
            <a:r>
              <a:rPr lang="en-US" sz="12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1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9465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41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5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dirty="0">
                <a:latin typeface="Calibri" pitchFamily="34" charset="0"/>
              </a:rPr>
              <a:t>Nitrates</a:t>
            </a:r>
            <a:endParaRPr lang="he-IL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1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975" y="4927600"/>
            <a:ext cx="6721475" cy="166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2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3975" y="1039813"/>
            <a:ext cx="6721475" cy="166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3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3975" y="2982913"/>
            <a:ext cx="6721475" cy="166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4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3975" y="6875463"/>
            <a:ext cx="6721475" cy="1662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79375" y="1003300"/>
            <a:ext cx="6794500" cy="366713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6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71438" y="4859338"/>
            <a:ext cx="6786562" cy="37941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6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58738" y="2970213"/>
            <a:ext cx="6716712" cy="322262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6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74613" y="6791325"/>
            <a:ext cx="6799262" cy="4032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6 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20489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41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6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dirty="0" err="1">
                <a:latin typeface="Calibri" pitchFamily="34" charset="0"/>
              </a:rPr>
              <a:t>Doxazosin</a:t>
            </a:r>
            <a:endParaRPr lang="he-IL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5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7325" y="5003800"/>
            <a:ext cx="6481763" cy="1993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506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7325" y="684213"/>
            <a:ext cx="6481763" cy="1920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507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36525" y="2771775"/>
            <a:ext cx="6461125" cy="1993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508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98438" y="7077075"/>
            <a:ext cx="6461125" cy="19954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211138" y="684213"/>
            <a:ext cx="6551612" cy="274637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7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220663" y="5003800"/>
            <a:ext cx="6534150" cy="31115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7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147638" y="2700338"/>
            <a:ext cx="6530975" cy="369887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7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217488" y="7067550"/>
            <a:ext cx="6534150" cy="290513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7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21513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41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7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dirty="0" err="1">
                <a:latin typeface="Calibri" pitchFamily="34" charset="0"/>
              </a:rPr>
              <a:t>Furosemide</a:t>
            </a:r>
            <a:r>
              <a:rPr lang="en-US" dirty="0">
                <a:latin typeface="Calibri" pitchFamily="34" charset="0"/>
              </a:rPr>
              <a:t> </a:t>
            </a:r>
            <a:endParaRPr lang="he-IL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29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4138" y="5003800"/>
            <a:ext cx="6153150" cy="1895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530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4138" y="785813"/>
            <a:ext cx="6153150" cy="1893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531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84138" y="2905125"/>
            <a:ext cx="6153150" cy="1895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532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4138" y="7143750"/>
            <a:ext cx="6153150" cy="1895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90488" y="730250"/>
            <a:ext cx="6551612" cy="338138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8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93663" y="4959350"/>
            <a:ext cx="6534150" cy="344488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8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71438" y="2833688"/>
            <a:ext cx="6530975" cy="3651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8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93663" y="7104063"/>
            <a:ext cx="6534150" cy="33972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8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22537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11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8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sz="1600" dirty="0">
                <a:latin typeface="Calibri" pitchFamily="34" charset="0"/>
              </a:rPr>
              <a:t>Oral </a:t>
            </a:r>
            <a:r>
              <a:rPr lang="en-US" sz="1600" dirty="0" err="1">
                <a:latin typeface="Calibri" pitchFamily="34" charset="0"/>
              </a:rPr>
              <a:t>hypoglycemics</a:t>
            </a:r>
            <a:endParaRPr lang="he-IL" sz="1600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3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7163" y="4127500"/>
            <a:ext cx="6565900" cy="138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3554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57163" y="611188"/>
            <a:ext cx="6565900" cy="138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3555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57163" y="2397125"/>
            <a:ext cx="6565900" cy="1382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3556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57163" y="5800725"/>
            <a:ext cx="6565900" cy="1382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תיבת טקסט 20"/>
          <p:cNvSpPr txBox="1"/>
          <p:nvPr/>
        </p:nvSpPr>
        <p:spPr>
          <a:xfrm>
            <a:off x="179388" y="539750"/>
            <a:ext cx="6551612" cy="382588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9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A :  Patients' Purchas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7" name="תיבת טקסט 8"/>
          <p:cNvSpPr txBox="1"/>
          <p:nvPr/>
        </p:nvSpPr>
        <p:spPr>
          <a:xfrm>
            <a:off x="182563" y="4054475"/>
            <a:ext cx="6534150" cy="373063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9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C :  Adherenc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8" name="תיבת טקסט 17"/>
          <p:cNvSpPr txBox="1"/>
          <p:nvPr/>
        </p:nvSpPr>
        <p:spPr>
          <a:xfrm>
            <a:off x="173038" y="2303463"/>
            <a:ext cx="6530975" cy="39687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9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B :  Documentation By Nurses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9" name="תיבת טקסט 3"/>
          <p:cNvSpPr txBox="1"/>
          <p:nvPr/>
        </p:nvSpPr>
        <p:spPr>
          <a:xfrm>
            <a:off x="176213" y="5767388"/>
            <a:ext cx="6534150" cy="344487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solidFill>
                  <a:srgbClr val="000000"/>
                </a:solidFill>
                <a:cs typeface="Arial" charset="0"/>
              </a:rPr>
              <a:t>Figure </a:t>
            </a:r>
            <a:r>
              <a:rPr lang="en-US" sz="1400" dirty="0" smtClean="0">
                <a:solidFill>
                  <a:srgbClr val="000000"/>
                </a:solidFill>
                <a:cs typeface="Arial" charset="0"/>
              </a:rPr>
              <a:t>S9 </a:t>
            </a:r>
            <a:r>
              <a:rPr lang="en-US" sz="1400" dirty="0">
                <a:solidFill>
                  <a:srgbClr val="000000"/>
                </a:solidFill>
                <a:cs typeface="Arial" charset="0"/>
              </a:rPr>
              <a:t>Plate D :  Relationship Between Nurses' documentation and patient purchase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  <a:p>
            <a:pPr algn="l" rtl="0">
              <a:lnSpc>
                <a:spcPct val="115000"/>
              </a:lnSpc>
              <a:spcAft>
                <a:spcPts val="1000"/>
              </a:spcAft>
            </a:pPr>
            <a:r>
              <a:rPr lang="en-US" sz="1600" dirty="0">
                <a:solidFill>
                  <a:srgbClr val="000000"/>
                </a:solidFill>
                <a:cs typeface="Arial" charset="0"/>
              </a:rPr>
              <a:t> </a:t>
            </a:r>
            <a:endParaRPr lang="en-US" sz="1200" dirty="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23561" name="מלבן 9"/>
          <p:cNvSpPr>
            <a:spLocks noChangeArrowheads="1"/>
          </p:cNvSpPr>
          <p:nvPr/>
        </p:nvSpPr>
        <p:spPr bwMode="auto">
          <a:xfrm>
            <a:off x="-26988" y="-36513"/>
            <a:ext cx="6900863" cy="611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 rtl="0"/>
            <a:r>
              <a:rPr lang="en-US" b="1" dirty="0">
                <a:latin typeface="Calibri" pitchFamily="34" charset="0"/>
              </a:rPr>
              <a:t>Online </a:t>
            </a:r>
            <a:r>
              <a:rPr lang="en-US" b="1" dirty="0" smtClean="0">
                <a:latin typeface="Calibri" pitchFamily="34" charset="0"/>
              </a:rPr>
              <a:t>Figure </a:t>
            </a:r>
            <a:r>
              <a:rPr lang="en-US" b="1" dirty="0" smtClean="0">
                <a:latin typeface="Calibri" pitchFamily="34" charset="0"/>
              </a:rPr>
              <a:t>S</a:t>
            </a:r>
            <a:r>
              <a:rPr lang="en-US" b="1" dirty="0" smtClean="0">
                <a:latin typeface="Calibri" pitchFamily="34" charset="0"/>
              </a:rPr>
              <a:t>9</a:t>
            </a:r>
            <a:endParaRPr lang="en-US" dirty="0">
              <a:latin typeface="Calibri" pitchFamily="34" charset="0"/>
            </a:endParaRPr>
          </a:p>
          <a:p>
            <a:pPr algn="l" rtl="0"/>
            <a:r>
              <a:rPr lang="en-US" sz="1600" dirty="0">
                <a:latin typeface="Calibri" pitchFamily="34" charset="0"/>
              </a:rPr>
              <a:t>Antidepressants</a:t>
            </a:r>
            <a:endParaRPr lang="he-IL" sz="1600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7</TotalTime>
  <Words>477</Words>
  <Application>Microsoft Office PowerPoint</Application>
  <PresentationFormat>On-screen Show (4:3)</PresentationFormat>
  <Paragraphs>134</Paragraphs>
  <Slides>1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4" baseType="lpstr">
      <vt:lpstr>ערכת נושא Offic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Inbal</dc:creator>
  <cp:lastModifiedBy>matan123</cp:lastModifiedBy>
  <cp:revision>42</cp:revision>
  <dcterms:created xsi:type="dcterms:W3CDTF">2013-07-01T18:00:57Z</dcterms:created>
  <dcterms:modified xsi:type="dcterms:W3CDTF">2014-10-19T08:15:50Z</dcterms:modified>
</cp:coreProperties>
</file>